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7-Oct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1" y="5470631"/>
            <a:ext cx="890794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. Antifungal activity-guided assay of the ethyl acetate extracts of </a:t>
            </a:r>
            <a:r>
              <a:rPr lang="en-US" sz="1400" b="1" i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. </a:t>
            </a:r>
            <a:r>
              <a:rPr lang="en-US" sz="1400" b="1" i="1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ladosporides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 towards various fungal isolates by well-diffusion assay.  Different concentrations of the crude ethyl acetate extract of </a:t>
            </a:r>
            <a:r>
              <a:rPr lang="en-US" sz="1400" b="1" i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. </a:t>
            </a:r>
            <a:r>
              <a:rPr lang="en-US" sz="1400" b="1" i="1" kern="100" dirty="0" err="1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ladosporides</a:t>
            </a:r>
            <a:r>
              <a:rPr lang="en-US" sz="1400" b="1" i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as assessed towards A. fumigatus (A), </a:t>
            </a:r>
            <a:r>
              <a:rPr lang="en-US" sz="1400" b="1" kern="100" dirty="0" err="1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usarium</a:t>
            </a:r>
            <a:r>
              <a:rPr lang="en-US" sz="1400" b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kern="100" dirty="0" err="1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xysporum</a:t>
            </a:r>
            <a:r>
              <a:rPr lang="en-US" sz="1400" b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B), F. </a:t>
            </a:r>
            <a:r>
              <a:rPr lang="en-US" sz="1400" b="1" kern="100" dirty="0" err="1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ani</a:t>
            </a:r>
            <a:r>
              <a:rPr lang="en-US" sz="1400" b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C) and Cladosporium </a:t>
            </a:r>
            <a:r>
              <a:rPr lang="en-US" sz="1400" b="1" kern="100" dirty="0" err="1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erbarum</a:t>
            </a:r>
            <a:r>
              <a:rPr lang="en-US" sz="1400" b="1" kern="100" dirty="0" smtClean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D)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402718" y="300248"/>
            <a:ext cx="4683882" cy="4576551"/>
            <a:chOff x="2402718" y="300249"/>
            <a:chExt cx="4339278" cy="4203506"/>
          </a:xfrm>
        </p:grpSpPr>
        <p:grpSp>
          <p:nvGrpSpPr>
            <p:cNvPr id="6" name="Group 5"/>
            <p:cNvGrpSpPr/>
            <p:nvPr/>
          </p:nvGrpSpPr>
          <p:grpSpPr>
            <a:xfrm>
              <a:off x="2471006" y="341193"/>
              <a:ext cx="4270990" cy="4162562"/>
              <a:chOff x="580131" y="1133317"/>
              <a:chExt cx="2375802" cy="2303717"/>
            </a:xfrm>
          </p:grpSpPr>
          <p:pic>
            <p:nvPicPr>
              <p:cNvPr id="11" name="Picture 10" descr="A petri dish with brown substance&#10;&#10;AI-generated content may be incorrect.">
                <a:extLst>
                  <a:ext uri="{FF2B5EF4-FFF2-40B4-BE49-F238E27FC236}">
                    <a16:creationId xmlns:a16="http://schemas.microsoft.com/office/drawing/2014/main" xmlns="" id="{E9B6F132-5968-EAFE-CFDB-1F48BAE743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580131" y="1133317"/>
                <a:ext cx="1115567" cy="1018353"/>
              </a:xfrm>
              <a:prstGeom prst="rect">
                <a:avLst/>
              </a:prstGeom>
            </p:spPr>
          </p:pic>
          <p:pic>
            <p:nvPicPr>
              <p:cNvPr id="12" name="Picture 11" descr="A petri dish with brown liquid&#10;&#10;AI-generated content may be incorrect.">
                <a:extLst>
                  <a:ext uri="{FF2B5EF4-FFF2-40B4-BE49-F238E27FC236}">
                    <a16:creationId xmlns:a16="http://schemas.microsoft.com/office/drawing/2014/main" xmlns="" id="{F5CCA3A4-A16C-296C-AD25-383B0D22FE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1815948" y="1133317"/>
                <a:ext cx="1097578" cy="1018354"/>
              </a:xfrm>
              <a:prstGeom prst="rect">
                <a:avLst/>
              </a:prstGeom>
            </p:spPr>
          </p:pic>
          <p:pic>
            <p:nvPicPr>
              <p:cNvPr id="13" name="Picture 12" descr="A round plastic container with black specks&#10;&#10;AI-generated content may be incorrect.">
                <a:extLst>
                  <a:ext uri="{FF2B5EF4-FFF2-40B4-BE49-F238E27FC236}">
                    <a16:creationId xmlns:a16="http://schemas.microsoft.com/office/drawing/2014/main" xmlns="" id="{2D8DFCED-B252-DC19-3A93-CEFAC208B1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587300" y="2329168"/>
                <a:ext cx="1108399" cy="1107866"/>
              </a:xfrm>
              <a:prstGeom prst="rect">
                <a:avLst/>
              </a:prstGeom>
            </p:spPr>
          </p:pic>
          <p:pic>
            <p:nvPicPr>
              <p:cNvPr id="14" name="Picture 13" descr="A petri dish with white substance&#10;&#10;AI-generated content may be incorrect.">
                <a:extLst>
                  <a:ext uri="{FF2B5EF4-FFF2-40B4-BE49-F238E27FC236}">
                    <a16:creationId xmlns:a16="http://schemas.microsoft.com/office/drawing/2014/main" xmlns="" id="{284B7C99-C6CD-6D70-5BBA-BC83022462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/>
            </p:blipFill>
            <p:spPr>
              <a:xfrm>
                <a:off x="1800764" y="2302271"/>
                <a:ext cx="1155169" cy="1112103"/>
              </a:xfrm>
              <a:prstGeom prst="rect">
                <a:avLst/>
              </a:prstGeom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2402718" y="300249"/>
              <a:ext cx="3220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638048" y="302312"/>
              <a:ext cx="3220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443710" y="2471515"/>
              <a:ext cx="3220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C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638047" y="2439716"/>
              <a:ext cx="32206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42315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6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raf</dc:creator>
  <cp:lastModifiedBy>Ashraf</cp:lastModifiedBy>
  <cp:revision>2</cp:revision>
  <dcterms:created xsi:type="dcterms:W3CDTF">2006-08-16T00:00:00Z</dcterms:created>
  <dcterms:modified xsi:type="dcterms:W3CDTF">2025-10-07T11:07:40Z</dcterms:modified>
</cp:coreProperties>
</file>